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10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008051" y="3610600"/>
            <a:ext cx="2602049" cy="2195786"/>
            <a:chOff x="28819" y="3842475"/>
            <a:chExt cx="2602049" cy="2195786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868" y="4129678"/>
              <a:ext cx="687600" cy="6876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7868" y="4817278"/>
              <a:ext cx="687600" cy="6876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85468" y="4129678"/>
              <a:ext cx="687600" cy="68760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85468" y="4811390"/>
              <a:ext cx="687600" cy="687600"/>
            </a:xfrm>
            <a:prstGeom prst="rect">
              <a:avLst/>
            </a:prstGeom>
          </p:spPr>
        </p:pic>
        <p:grpSp>
          <p:nvGrpSpPr>
            <p:cNvPr id="17" name="Group 16"/>
            <p:cNvGrpSpPr/>
            <p:nvPr/>
          </p:nvGrpSpPr>
          <p:grpSpPr>
            <a:xfrm>
              <a:off x="28819" y="3842475"/>
              <a:ext cx="2602049" cy="2195786"/>
              <a:chOff x="6263834" y="3146096"/>
              <a:chExt cx="2602049" cy="2195786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6483526" y="4794927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718754" y="4797187"/>
                <a:ext cx="5059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890904" y="4795926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052041" y="4793546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3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7210624" y="4793320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4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479915" y="4567495"/>
                <a:ext cx="5059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483526" y="4402548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6479347" y="4234799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3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6482878" y="4068891"/>
                <a:ext cx="54049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4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1" name="Group 51"/>
              <p:cNvGrpSpPr/>
              <p:nvPr/>
            </p:nvGrpSpPr>
            <p:grpSpPr>
              <a:xfrm>
                <a:off x="6493662" y="4638461"/>
                <a:ext cx="457200" cy="457200"/>
                <a:chOff x="609590" y="2083234"/>
                <a:chExt cx="457200" cy="457200"/>
              </a:xfrm>
            </p:grpSpPr>
            <p:cxnSp>
              <p:nvCxnSpPr>
                <p:cNvPr id="42" name="Straight Arrow Connector 41"/>
                <p:cNvCxnSpPr/>
                <p:nvPr/>
              </p:nvCxnSpPr>
              <p:spPr>
                <a:xfrm>
                  <a:off x="609590" y="2533650"/>
                  <a:ext cx="457200" cy="158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Arrow Connector 42"/>
                <p:cNvCxnSpPr/>
                <p:nvPr/>
              </p:nvCxnSpPr>
              <p:spPr>
                <a:xfrm rot="5400000" flipH="1" flipV="1">
                  <a:off x="389284" y="2311040"/>
                  <a:ext cx="457200" cy="158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TextBox 31"/>
              <p:cNvSpPr txBox="1"/>
              <p:nvPr/>
            </p:nvSpPr>
            <p:spPr>
              <a:xfrm>
                <a:off x="6419485" y="5095661"/>
                <a:ext cx="10119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CD45/B7.2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>
                <a:off x="5999638" y="4596499"/>
                <a:ext cx="7746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CD11b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823317" y="3146101"/>
                <a:ext cx="7746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CD45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560711" y="3146096"/>
                <a:ext cx="10725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B7.2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091269" y="4302128"/>
                <a:ext cx="7746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LHVS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8072104" y="3605764"/>
                <a:ext cx="7746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DMSO 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7658304" y="4101380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8.6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7006747" y="4100413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8.3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7666327" y="3410163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8.2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6971640" y="3415446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97.6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44" name="TextBox 43"/>
          <p:cNvSpPr txBox="1"/>
          <p:nvPr/>
        </p:nvSpPr>
        <p:spPr>
          <a:xfrm>
            <a:off x="534386" y="6032118"/>
            <a:ext cx="594822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MMØ treated with 5 µg/ml LHVS do not exhibit modified cell survival, or surface expression of CD11b, CD45, or B7.2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were exposed to LHVS for 24 h (5 µg/ml unless otherwise indicated) and assessed for cell viability b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ypa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lue exclusion using standard protocols.  Surface expression of CD11b, CD45, and B7.2 were analyzed by flow cytometry follow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tainin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f the treated BMMØs. 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ata represent 3 independent experime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ata presented as mean +/- SEM (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NOVA, p&lt;0.05); significant differences from internal WT controls are denoted by asterisks (*). </a:t>
            </a:r>
          </a:p>
        </p:txBody>
      </p:sp>
      <p:pic>
        <p:nvPicPr>
          <p:cNvPr id="4098" name="Picture 2" descr="C:\Users\Euan\Desktop\Euan's LAB NEW\Manuscripts\CAT EAE Manuscript\CAT BSL Paper\Prizm FIles\High Res pannels\S5 aTrypan Blue lhvs.ti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6276" y="876669"/>
            <a:ext cx="1944624" cy="19446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Euan\Desktop\Euan's LAB NEW\Manuscripts\CAT EAE Manuscript\CAT BSL Paper\Prizm FIles\High Res pannels\S5 B LHVS on CD45 cd11b b7.tif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5259" y="791366"/>
            <a:ext cx="3029712" cy="19110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02088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127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8:19Z</dcterms:modified>
</cp:coreProperties>
</file>